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36" d="100"/>
          <a:sy n="36" d="100"/>
        </p:scale>
        <p:origin x="2427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8850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81203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8265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32166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6817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9506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28117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2379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3091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7646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964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15ED5-DBD9-4743-9511-B37AED68BA98}" type="datetimeFigureOut">
              <a:rPr lang="en-AU" smtClean="0"/>
              <a:t>16/01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264BF-D238-4EA6-96C0-CF380B460FB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3564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361670D-6573-491B-B575-E076F96CC7E6}"/>
              </a:ext>
            </a:extLst>
          </p:cNvPr>
          <p:cNvSpPr txBox="1"/>
          <p:nvPr/>
        </p:nvSpPr>
        <p:spPr>
          <a:xfrm>
            <a:off x="478367" y="1934379"/>
            <a:ext cx="62314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Fig. S2</a:t>
            </a:r>
            <a:r>
              <a:rPr lang="en-AU" sz="1400" dirty="0"/>
              <a:t>: Identity between the VHPO protein of isolate 4388 and the published </a:t>
            </a:r>
            <a:r>
              <a:rPr lang="en-AU" sz="1400" i="1" dirty="0"/>
              <a:t>C. </a:t>
            </a:r>
            <a:r>
              <a:rPr lang="en-AU" sz="1400" i="1" dirty="0" err="1"/>
              <a:t>inaequalis</a:t>
            </a:r>
            <a:r>
              <a:rPr lang="en-AU" sz="1400" i="1" dirty="0"/>
              <a:t> </a:t>
            </a:r>
            <a:r>
              <a:rPr lang="en-AU" sz="1400" dirty="0"/>
              <a:t>enzyme (</a:t>
            </a:r>
            <a:r>
              <a:rPr lang="en-AU" sz="1400" dirty="0" err="1"/>
              <a:t>Genbank</a:t>
            </a:r>
            <a:r>
              <a:rPr lang="en-AU" sz="1400" dirty="0"/>
              <a:t> </a:t>
            </a:r>
            <a:r>
              <a:rPr lang="en-AU" sz="1800" dirty="0">
                <a:effectLst/>
                <a:ea typeface="Calibri" panose="020F0502020204030204" pitchFamily="34" charset="0"/>
              </a:rPr>
              <a:t>CAA59686).</a:t>
            </a:r>
            <a:endParaRPr lang="en-AU" sz="1400" dirty="0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B375C66A-C269-423F-93B9-6B47F274D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" y="728133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69686532-C80E-4341-AC7B-855B233772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" y="1185333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936F3A-9E1E-B1BD-D641-25DC6E56AF3C}"/>
              </a:ext>
            </a:extLst>
          </p:cNvPr>
          <p:cNvSpPr txBox="1"/>
          <p:nvPr/>
        </p:nvSpPr>
        <p:spPr>
          <a:xfrm>
            <a:off x="724957" y="3526065"/>
            <a:ext cx="5984876" cy="5262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MGSVTPIPLPKIDEPEEYNTNYILFWNHVGLELNRVTHTVGGPLTGPPLSARALGMLHLA	6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MGS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PIPLPKIDEPEEYNTNYILFWNHVGLELNRVTHTVGGPLTGPPLSARALGMLHLA	60 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:********************************************************     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</a:t>
            </a: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IHDAYFSICPPTDFTTFLSPDTENAAYRLPSPNGANDARQAVAGAALKMLSSLYMKPVEQ	12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IHDAYFSI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PTDF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FLSP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NAAYRLPSPNGANDARQAVAGAALKML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SLYMKPVE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	120   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 *****:*****::****************************:********    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	</a:t>
            </a: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NPNPGANISDNAYAQLGLVLDRSVLEAPGGVDRESASFMFGEDVADVFFALLNDPRGAS	18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PNPNPGANISDNAYAQL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LV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DRSVL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PGGVDRESASFMFGE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VADVFFALLNDPRGAS	18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.**:*****:**************** ************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QEGYHPTPGRYKFDDEPTHPVVLIPVDPNNPNGPKMPFRQYHAPFYGKTTKRFATQSEHF	24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QEGYHPTPGRYKFDDEPTHPVVLIPVDPNNPNGPK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FRQYHAPFYGKTTKRFATQSEHF	24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*************** ********************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LADPPGLRSNADETAEYDDAVRVAIAMGGAQALNSTKRSPWQTAQGLYWAYDGSNLIGTP	30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LADPPGLRSNADETAEYDDA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VAIAMGGAQALNSTKRSPWQTAQGL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WAYDGSNLIGTP	30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:**************************:********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RFYNQIVRRIAVTYKKEEDLANSEVNNADFARLFALVDVACTDAGIFSWKEKWEFEFWR	36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PRFYNQIVRRIAVTYKKEEDLANSEVNNADFARLFALVDVACTDAGIFSWKEKWE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Y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FWR	36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***********************************: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PLSGVRDDGRPDHGDPFWLTLGAPATNTNDIPFKPPFPAYPSGHATFGGAVFQMVRRYYN	42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PLSGVRDDGRPDHGDPFWLTLGAPATNTNDIPFKPPFPAYPSGHATFGGAVFQMVRRYYN	42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************************************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RVGTWKDDEPDNIAIDMMISEELNGVNRDLRQPYDPTAPIEDQPGIVRTRIVRHFDSAW	48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GRVGTWKDDEPDNIAIDMMISEELNG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NRDLRQPYDPTAPIEDQPGIVRTRIVRHFDSAW	48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******:*******************************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LMFENAISRIFLGVHWRFDAAAARDILIPTTTKDVYAVDNNGATVFQNVEDIRYTTRGT	54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ELMFENAISRIFLGVHWRFDAAAARDILIPTTTKDVYAVDNNGATVFQNVEDIRYTT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T	540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*****************************************************:**</a:t>
            </a:r>
          </a:p>
          <a:p>
            <a:endParaRPr lang="en-AU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REDPEGLFPIGGVPLGIEIADEIFNNGLKPTPPEIQPMPQETPVQKPVGQQPVKGMWEEE	600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RED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GLFPIGGVPLGIEIADEIFNNGLKPTPPE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QPMPQ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PVQKPVGQQPV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MW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EE	600          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 ******************************:*****:************:*** **</a:t>
            </a:r>
          </a:p>
          <a:p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C. </a:t>
            </a:r>
            <a:r>
              <a:rPr lang="en-AU" sz="800" i="1" dirty="0" err="1">
                <a:latin typeface="Courier New" panose="02070309020205020404" pitchFamily="49" charset="0"/>
                <a:cs typeface="Courier New" panose="02070309020205020404" pitchFamily="49" charset="0"/>
              </a:rPr>
              <a:t>inequalis</a:t>
            </a:r>
            <a:r>
              <a:rPr lang="en-AU" sz="800" i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QAPVVKEAP	609</a:t>
            </a:r>
          </a:p>
          <a:p>
            <a:pPr marL="228600" indent="-228600">
              <a:buAutoNum type="arabicPlain" startAt="4388"/>
            </a:pP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QAPV</a:t>
            </a:r>
            <a:r>
              <a:rPr lang="en-AU" sz="8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KEAP	609</a:t>
            </a:r>
          </a:p>
          <a:p>
            <a:r>
              <a:rPr lang="en-AU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****:****</a:t>
            </a:r>
          </a:p>
        </p:txBody>
      </p:sp>
    </p:spTree>
    <p:extLst>
      <p:ext uri="{BB962C8B-B14F-4D97-AF65-F5344CB8AC3E}">
        <p14:creationId xmlns:p14="http://schemas.microsoft.com/office/powerpoint/2010/main" val="1064286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</TotalTime>
  <Words>163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&amp;F, Black Mountain)</dc:creator>
  <cp:lastModifiedBy>Ayliffe, Michael (A&amp;F, Black Mountain)</cp:lastModifiedBy>
  <cp:revision>24</cp:revision>
  <dcterms:created xsi:type="dcterms:W3CDTF">2022-03-29T03:56:09Z</dcterms:created>
  <dcterms:modified xsi:type="dcterms:W3CDTF">2025-01-15T23:06:18Z</dcterms:modified>
</cp:coreProperties>
</file>